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20" y="9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1/04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1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Ngara</a:t>
            </a:r>
            <a:r>
              <a:rPr lang="en-GB" dirty="0"/>
              <a:t> and </a:t>
            </a:r>
            <a:r>
              <a:rPr lang="en-GB" dirty="0" err="1"/>
              <a:t>Wierup</a:t>
            </a:r>
            <a:r>
              <a:rPr lang="en-GB" dirty="0"/>
              <a:t> (2022) Diabetologia DOI 10.1007/s00125-022-05699-1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Differentially expressed genes in distinct islet cell types across four dataset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E0C702C-2592-422F-AA2C-1446620B43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87780" y="5075545"/>
            <a:ext cx="1177305" cy="50668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A61A72D-3DF8-467C-8D5D-35F871D4183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37139" y="959252"/>
            <a:ext cx="4750641" cy="46531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</TotalTime>
  <Words>52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40</cp:revision>
  <dcterms:created xsi:type="dcterms:W3CDTF">2016-06-15T12:53:43Z</dcterms:created>
  <dcterms:modified xsi:type="dcterms:W3CDTF">2022-04-11T16:27:26Z</dcterms:modified>
</cp:coreProperties>
</file>